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9" d="100"/>
          <a:sy n="89" d="100"/>
        </p:scale>
        <p:origin x="69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59C982E-89F3-EF65-AC5C-ACBB06C9AF7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4D68F2D-3559-747C-C269-C7410614429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BD87953-B776-DE0E-7AD8-3719DFED2A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C4F49-1C2B-46F5-8365-7077ED5B7A11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9DAD94B-BC4B-337C-3A80-12EB718B12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C7E9D57-389A-0297-2C51-7AD9B9CE23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EA4AD-D08C-4056-9008-249274C768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28022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F3FCEA6-9C67-5413-08DD-A45C843FC5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3EC20F8-4071-106D-2879-3D3EB12423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BBB1A1C-6A75-7EE2-7C5B-6E17114CBC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C4F49-1C2B-46F5-8365-7077ED5B7A11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E162D51-7716-C5B2-84CA-3F40EC95B3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2ED740D-2780-89A3-A048-A26560F0EE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EA4AD-D08C-4056-9008-249274C768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276838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0FEFEC5-63B4-D6C5-756E-DDD91C7E98C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E868AFB-9E91-B2BB-24C0-0B8D8915CC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CA1EF69-DBF7-64B6-799F-53945EFEB7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C4F49-1C2B-46F5-8365-7077ED5B7A11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C8CE79E-F30F-A1A6-60FA-56B408B731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20521D6-7916-EFDB-9EE4-4E0DCE7A2B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EA4AD-D08C-4056-9008-249274C768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71380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024309A-47B3-0CF9-44FD-7125C9E188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D6A027D-DBE6-7E52-BCF4-E6DCBB9EF10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8C46B04-94C7-F0DD-65BA-64243EFCDF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C4F49-1C2B-46F5-8365-7077ED5B7A11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AA04E6D-D799-C121-1E7B-F1D3606E49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7BAB2F8-951B-24B3-E195-6692CDD36A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EA4AD-D08C-4056-9008-249274C768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1096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92DF710-D411-3E63-593C-7DC4494E7D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7AA2131-C5FC-687D-6D1E-F3DA3E5999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D676DCC-6110-18EC-3505-90C767E7FD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C4F49-1C2B-46F5-8365-7077ED5B7A11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F817A02-71BA-A3CF-123A-BB4E49579C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862194E-6F5B-6B81-27B0-BAEF79610D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EA4AD-D08C-4056-9008-249274C768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01685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CC3519D-4075-6DEF-086E-DD63E2C265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AEB81BA-ED96-3B8E-67CA-651D3D2DD82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DC3BFA8-C746-EE83-986F-B4566955DB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24D223D-1C24-1D34-8CC7-9A76BBC604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C4F49-1C2B-46F5-8365-7077ED5B7A11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D9DBFE7-2E31-1328-2E67-3DFE3680CD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BC92164-C934-DE82-8F2F-CFC814AD88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EA4AD-D08C-4056-9008-249274C768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2939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C3AB9EC-0538-2BF6-E2AD-C81853AF2F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51BA492-052F-9A48-B41A-E8347BFCD4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EF29168-485C-6BFE-91BC-7F84C0C74C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CAFA694-E87F-2681-927A-A49DCFB16CC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1A081BF-6CF9-C30E-0834-399708022C6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34073A9-6E81-4C74-C613-9355D128F0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C4F49-1C2B-46F5-8365-7077ED5B7A11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D54895F-16F3-CB21-6D50-EF3F5B47E9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79B95000-EFC0-B609-1FDC-EB072AC7C0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EA4AD-D08C-4056-9008-249274C768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11829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09C589D-9E24-FD2C-BD48-BB26BE99E1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C659FFDD-EFB1-D86E-BA68-F55879BE7C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C4F49-1C2B-46F5-8365-7077ED5B7A11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F9BDA2D-A351-CF13-751A-C0DAA483D9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DEF8513-4182-8106-70B8-396010A601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EA4AD-D08C-4056-9008-249274C768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57977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1E2BEEE-626A-A5AE-454B-8E99DA5235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C4F49-1C2B-46F5-8365-7077ED5B7A11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0B3487D-45E7-1B78-E724-FD0F4E5A8D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3DC00CA-8924-DAE2-61CE-AAD91210AD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EA4AD-D08C-4056-9008-249274C768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8551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BF58BA5-3961-7420-6B83-68F295F030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02F6A60-8F50-5BB9-0D68-045839F11C6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7869494-2F20-10AD-1F7F-AE5715C724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03379C0-0B6B-262F-FA54-74F7171CDF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C4F49-1C2B-46F5-8365-7077ED5B7A11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7121607-6D58-2D71-5B88-C67FD29135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ECA4529-6B38-E084-F033-DA8B3D6C2F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EA4AD-D08C-4056-9008-249274C768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75632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2BE12E1-BDAF-1FBA-A66D-517566F3D0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0A9F616-1930-9544-7657-715BC5F8C1A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BD76ECB-871A-908D-B90B-8A098D7118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B873616-88DD-F50B-7A2F-797476503D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C4F49-1C2B-46F5-8365-7077ED5B7A11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D5E4897-E8D5-5719-F0D1-5C54D4DD4E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3AE7078-113B-34A2-FAC3-74A618C080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EA4AD-D08C-4056-9008-249274C768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29472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57DB8237-BDBC-A049-1E4B-951505C458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828299C-425B-12C9-E7EC-FEEBBC55DE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51F46EB-82EF-823B-5AA6-560EF17EB8C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7C4F49-1C2B-46F5-8365-7077ED5B7A11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3B510D5-6F16-4260-D6D5-ACCA1A42239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DFD33B7-D8F5-4D83-DD69-9BF1BCE8B46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0EA4AD-D08C-4056-9008-249274C768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4374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C953FDCE-6773-11B2-ECF0-D0498291656B}"/>
              </a:ext>
            </a:extLst>
          </p:cNvPr>
          <p:cNvSpPr txBox="1"/>
          <p:nvPr/>
        </p:nvSpPr>
        <p:spPr>
          <a:xfrm>
            <a:off x="9353191" y="5728742"/>
            <a:ext cx="255126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Supplementary Figure </a:t>
            </a:r>
            <a:r>
              <a:rPr lang="en-US" altLang="zh-CN" dirty="0"/>
              <a:t>1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3884E00E-9019-195A-9100-2FBACFDE4BD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6361" y="0"/>
            <a:ext cx="809949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39499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EB3270C-0C09-E5F6-CF90-B006B6B5F356}"/>
              </a:ext>
            </a:extLst>
          </p:cNvPr>
          <p:cNvSpPr txBox="1"/>
          <p:nvPr/>
        </p:nvSpPr>
        <p:spPr>
          <a:xfrm>
            <a:off x="9353191" y="5728742"/>
            <a:ext cx="255126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Supplementary Figure </a:t>
            </a:r>
            <a:r>
              <a:rPr lang="en-US" altLang="zh-CN" dirty="0"/>
              <a:t>2</a:t>
            </a:r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5E388159-10FD-2450-147B-BB7B825A8FF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2032" y="0"/>
            <a:ext cx="768024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086118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D0E3EBD-3AC2-6910-2ED9-FAB36972C0D3}"/>
              </a:ext>
            </a:extLst>
          </p:cNvPr>
          <p:cNvSpPr txBox="1"/>
          <p:nvPr/>
        </p:nvSpPr>
        <p:spPr>
          <a:xfrm>
            <a:off x="9353191" y="5728742"/>
            <a:ext cx="255126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Supplementary Figure </a:t>
            </a:r>
            <a:r>
              <a:rPr lang="en-US" altLang="zh-CN" dirty="0"/>
              <a:t>3</a:t>
            </a:r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D4A18C25-CD15-441D-B7FC-03274DBF9F9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7873" y="0"/>
            <a:ext cx="764316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576029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C9669103-BE1C-EF37-9577-C46927DEA928}"/>
              </a:ext>
            </a:extLst>
          </p:cNvPr>
          <p:cNvSpPr txBox="1"/>
          <p:nvPr/>
        </p:nvSpPr>
        <p:spPr>
          <a:xfrm>
            <a:off x="9353191" y="5728742"/>
            <a:ext cx="255126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Supplementary Figure </a:t>
            </a:r>
            <a:r>
              <a:rPr lang="en-US" altLang="zh-CN" dirty="0"/>
              <a:t>4</a:t>
            </a:r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9FC72D9A-0428-BB36-EEF8-D65F0B70775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8952" y="0"/>
            <a:ext cx="792573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51897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EF558F82-B43D-71DE-7A7A-4A7ADDA34426}"/>
              </a:ext>
            </a:extLst>
          </p:cNvPr>
          <p:cNvSpPr txBox="1"/>
          <p:nvPr/>
        </p:nvSpPr>
        <p:spPr>
          <a:xfrm>
            <a:off x="9353191" y="5728742"/>
            <a:ext cx="255126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Supplementary Figure </a:t>
            </a:r>
            <a:r>
              <a:rPr lang="en-US" altLang="zh-CN" dirty="0"/>
              <a:t>5</a:t>
            </a:r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2BA613E0-4399-A203-6466-D534C1978BA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3813" y="0"/>
            <a:ext cx="609657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9111093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C6A3BD31-0E96-16A7-52DD-F842485FB93C}"/>
              </a:ext>
            </a:extLst>
          </p:cNvPr>
          <p:cNvSpPr txBox="1"/>
          <p:nvPr/>
        </p:nvSpPr>
        <p:spPr>
          <a:xfrm>
            <a:off x="9353191" y="5728742"/>
            <a:ext cx="255126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Supplementary Figure </a:t>
            </a:r>
            <a:r>
              <a:rPr lang="en-US" altLang="zh-CN" dirty="0"/>
              <a:t>6</a:t>
            </a:r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C1F490D1-1DC8-0F39-E6CC-1C63B3A8113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6042" y="628058"/>
            <a:ext cx="10386204" cy="51101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550661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1465048-DF54-F06C-E8CA-0F354AE84DD4}"/>
              </a:ext>
            </a:extLst>
          </p:cNvPr>
          <p:cNvSpPr txBox="1"/>
          <p:nvPr/>
        </p:nvSpPr>
        <p:spPr>
          <a:xfrm>
            <a:off x="9353191" y="5728742"/>
            <a:ext cx="255126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Supplementary Figure </a:t>
            </a:r>
            <a:r>
              <a:rPr lang="en-US" altLang="zh-CN" dirty="0"/>
              <a:t>7</a:t>
            </a:r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F9568AD7-11E2-D574-A270-9A00B097442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9624" y="194310"/>
            <a:ext cx="7607808" cy="64693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584846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1</Words>
  <Application>Microsoft Office PowerPoint</Application>
  <PresentationFormat>宽屏</PresentationFormat>
  <Paragraphs>7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1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微软中国</dc:creator>
  <cp:lastModifiedBy>微软中国</cp:lastModifiedBy>
  <cp:revision>2</cp:revision>
  <dcterms:created xsi:type="dcterms:W3CDTF">2023-03-25T04:30:21Z</dcterms:created>
  <dcterms:modified xsi:type="dcterms:W3CDTF">2023-06-17T00:32:40Z</dcterms:modified>
</cp:coreProperties>
</file>